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1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om du vill redigera mall för underrubrikformat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80180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61738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87869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1455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10801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9476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5893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79895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7990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46454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1091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5CB16-ECC4-4802-A590-B61C22F86C58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201F9D-7B80-4988-8836-01C05D268F0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32191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: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estational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abetes and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 of active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bour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– a directed acyclic graph to define and display confounders and mediators.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15569" y="1825625"/>
            <a:ext cx="9360862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1565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23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Figure S2: Pregestational diabetes and duration of active labour – a directed acyclic graph to define and display confounders and mediators.</vt:lpstr>
    </vt:vector>
  </TitlesOfParts>
  <Company>Region Östergöt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: Type 1 diabetes and time in active labor – a directed acyclic graph to define and display confounders and intermediars</dc:title>
  <dc:creator>Nevander Sofia</dc:creator>
  <cp:lastModifiedBy>Nevander Sofia</cp:lastModifiedBy>
  <cp:revision>14</cp:revision>
  <dcterms:created xsi:type="dcterms:W3CDTF">2023-06-08T14:25:57Z</dcterms:created>
  <dcterms:modified xsi:type="dcterms:W3CDTF">2025-06-16T08:19:52Z</dcterms:modified>
</cp:coreProperties>
</file>